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97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Arkusz_programu_Microsoft_Excel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ocuments%20and%20Settings\pawel\Pulpit\Obrobione%20wyniki%20do%20publikacji%20human%20mutation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ocuments%20and%20Settings\pawel\Pulpit\Obrobione%20wyniki%20do%20publikacji%20human%20mutation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pawel\Pulpit\Obrobione%20wyniki%20do%20publikacji%20human%20mu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546040666078565"/>
          <c:y val="4.2908288637833331E-2"/>
          <c:w val="0.8705654116886844"/>
          <c:h val="0.784392863935486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660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FFFF00"/>
              </a:solidFill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  <c:spPr>
              <a:solidFill>
                <a:srgbClr val="FFFF00"/>
              </a:solidFill>
            </c:spPr>
          </c:dPt>
          <c:dPt>
            <c:idx val="3"/>
            <c:invertIfNegative val="0"/>
            <c:bubble3D val="0"/>
          </c:dPt>
          <c:dPt>
            <c:idx val="4"/>
            <c:invertIfNegative val="0"/>
            <c:bubble3D val="0"/>
            <c:spPr>
              <a:solidFill>
                <a:srgbClr val="FFFF0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FF00"/>
              </a:solidFill>
            </c:spPr>
          </c:dPt>
          <c:dPt>
            <c:idx val="7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9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0070C0"/>
              </a:solidFill>
            </c:spPr>
          </c:dPt>
          <c:cat>
            <c:strRef>
              <c:f>Arkusz1!$C$8:$N$8</c:f>
              <c:strCache>
                <c:ptCount val="12"/>
                <c:pt idx="0">
                  <c:v>1. Female - Amplification</c:v>
                </c:pt>
                <c:pt idx="1">
                  <c:v>2. Female - Wt</c:v>
                </c:pt>
                <c:pt idx="2">
                  <c:v>3. Female - Amplification</c:v>
                </c:pt>
                <c:pt idx="3">
                  <c:v>4. Female - Wt</c:v>
                </c:pt>
                <c:pt idx="4">
                  <c:v>5. Female - Amplification</c:v>
                </c:pt>
                <c:pt idx="5">
                  <c:v>6. Female - Amplification</c:v>
                </c:pt>
                <c:pt idx="6">
                  <c:v>7. Female - Wt</c:v>
                </c:pt>
                <c:pt idx="7">
                  <c:v>8. Male - Amplification</c:v>
                </c:pt>
                <c:pt idx="8">
                  <c:v>9. Female - Wt</c:v>
                </c:pt>
                <c:pt idx="9">
                  <c:v>10. Male - Wt</c:v>
                </c:pt>
                <c:pt idx="10">
                  <c:v>11. Male - Wt</c:v>
                </c:pt>
                <c:pt idx="11">
                  <c:v>12. Male - Wt</c:v>
                </c:pt>
              </c:strCache>
            </c:strRef>
          </c:cat>
          <c:val>
            <c:numRef>
              <c:f>Arkusz1!$C$6:$N$6</c:f>
              <c:numCache>
                <c:formatCode>General</c:formatCode>
                <c:ptCount val="12"/>
                <c:pt idx="0">
                  <c:v>1.5291774617058564</c:v>
                </c:pt>
                <c:pt idx="1">
                  <c:v>0.99901922576253999</c:v>
                </c:pt>
                <c:pt idx="2">
                  <c:v>1.5506493431159474</c:v>
                </c:pt>
                <c:pt idx="3">
                  <c:v>0.94823788816851129</c:v>
                </c:pt>
                <c:pt idx="4">
                  <c:v>1.5639942730452336</c:v>
                </c:pt>
                <c:pt idx="5">
                  <c:v>1.5201042289770399</c:v>
                </c:pt>
                <c:pt idx="6">
                  <c:v>0.99094819796766076</c:v>
                </c:pt>
                <c:pt idx="7">
                  <c:v>1.0171887662059322</c:v>
                </c:pt>
                <c:pt idx="8">
                  <c:v>0.99931152289658987</c:v>
                </c:pt>
                <c:pt idx="9">
                  <c:v>0.53839282730762894</c:v>
                </c:pt>
                <c:pt idx="10">
                  <c:v>0.48968591510266996</c:v>
                </c:pt>
                <c:pt idx="11">
                  <c:v>0.438445846187998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941568"/>
        <c:axId val="136943104"/>
      </c:barChart>
      <c:catAx>
        <c:axId val="136941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pl-PL"/>
          </a:p>
        </c:txPr>
        <c:crossAx val="13694310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36943104"/>
        <c:scaling>
          <c:orientation val="minMax"/>
        </c:scaling>
        <c:delete val="0"/>
        <c:axPos val="l"/>
        <c:majorGridlines>
          <c:spPr>
            <a:ln>
              <a:solidFill>
                <a:srgbClr val="000000"/>
              </a:solidFill>
            </a:ln>
          </c:spPr>
        </c:majorGridlines>
        <c:minorGridlines>
          <c:spPr>
            <a:ln>
              <a:solidFill>
                <a:sysClr val="windowText" lastClr="000000">
                  <a:alpha val="22000"/>
                </a:sysClr>
              </a:solidFill>
              <a:prstDash val="sysDash"/>
            </a:ln>
          </c:spPr>
        </c:minorGridlines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ormalized peak height ratio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in"/>
        <c:tickLblPos val="nextTo"/>
        <c:spPr>
          <a:noFill/>
        </c:spPr>
        <c:txPr>
          <a:bodyPr rot="0" vert="horz"/>
          <a:lstStyle/>
          <a:p>
            <a:pPr>
              <a:defRPr/>
            </a:pPr>
            <a:endParaRPr lang="pl-PL"/>
          </a:p>
        </c:txPr>
        <c:crossAx val="136941568"/>
        <c:crosses val="autoZero"/>
        <c:crossBetween val="between"/>
        <c:majorUnit val="0.5"/>
        <c:minorUnit val="0.05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546040666078565"/>
          <c:y val="4.2908288637833379E-2"/>
          <c:w val="0.87056541168868506"/>
          <c:h val="0.784392863935486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660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CC0066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3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6"/>
            <c:invertIfNegative val="0"/>
            <c:bubble3D val="0"/>
            <c:spPr>
              <a:solidFill>
                <a:srgbClr val="FF0000"/>
              </a:solidFill>
            </c:spPr>
          </c:dPt>
          <c:dPt>
            <c:idx val="7"/>
            <c:invertIfNegative val="0"/>
            <c:bubble3D val="0"/>
            <c:spPr>
              <a:solidFill>
                <a:srgbClr val="FF0000"/>
              </a:solidFill>
            </c:spPr>
          </c:dPt>
          <c:cat>
            <c:strRef>
              <c:f>Arkusz1!$C$63:$N$63</c:f>
              <c:strCache>
                <c:ptCount val="12"/>
                <c:pt idx="0">
                  <c:v>1. Male - Deletion</c:v>
                </c:pt>
                <c:pt idx="1">
                  <c:v>2. Wt</c:v>
                </c:pt>
                <c:pt idx="2">
                  <c:v>3. Female - Deletion</c:v>
                </c:pt>
                <c:pt idx="3">
                  <c:v>4. Female - Deletion</c:v>
                </c:pt>
                <c:pt idx="4">
                  <c:v>5. Wt</c:v>
                </c:pt>
                <c:pt idx="5">
                  <c:v>6. Male - Deletion</c:v>
                </c:pt>
                <c:pt idx="6">
                  <c:v>7. Male - Deletion</c:v>
                </c:pt>
                <c:pt idx="7">
                  <c:v>8. Male - Deletion</c:v>
                </c:pt>
                <c:pt idx="8">
                  <c:v>9. Wt</c:v>
                </c:pt>
                <c:pt idx="9">
                  <c:v>10. Wt</c:v>
                </c:pt>
                <c:pt idx="10">
                  <c:v>11. Wt</c:v>
                </c:pt>
                <c:pt idx="11">
                  <c:v>12. Wt</c:v>
                </c:pt>
              </c:strCache>
            </c:strRef>
          </c:cat>
          <c:val>
            <c:numRef>
              <c:f>Arkusz1!$C$61:$N$61</c:f>
              <c:numCache>
                <c:formatCode>General</c:formatCode>
                <c:ptCount val="12"/>
                <c:pt idx="0">
                  <c:v>9.0842678767098211E-3</c:v>
                </c:pt>
                <c:pt idx="1">
                  <c:v>0.91300000000000003</c:v>
                </c:pt>
                <c:pt idx="2">
                  <c:v>0.50194760148100381</c:v>
                </c:pt>
                <c:pt idx="3">
                  <c:v>0.54564287952729718</c:v>
                </c:pt>
                <c:pt idx="4">
                  <c:v>0.97597264810901363</c:v>
                </c:pt>
                <c:pt idx="5">
                  <c:v>1.1069619546726459E-2</c:v>
                </c:pt>
                <c:pt idx="6">
                  <c:v>1.4593476105205009E-2</c:v>
                </c:pt>
                <c:pt idx="7">
                  <c:v>1.8454095936362283E-2</c:v>
                </c:pt>
                <c:pt idx="8">
                  <c:v>0.94037324012425438</c:v>
                </c:pt>
                <c:pt idx="9">
                  <c:v>1.0166363150614171</c:v>
                </c:pt>
                <c:pt idx="10">
                  <c:v>1.0845837212553806</c:v>
                </c:pt>
                <c:pt idx="11">
                  <c:v>0.958406723558947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746752"/>
        <c:axId val="146748544"/>
      </c:barChart>
      <c:catAx>
        <c:axId val="146746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pl-PL"/>
          </a:p>
        </c:txPr>
        <c:crossAx val="14674854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46748544"/>
        <c:scaling>
          <c:orientation val="minMax"/>
        </c:scaling>
        <c:delete val="0"/>
        <c:axPos val="l"/>
        <c:majorGridlines>
          <c:spPr>
            <a:ln>
              <a:solidFill>
                <a:srgbClr val="000000"/>
              </a:solidFill>
            </a:ln>
          </c:spPr>
        </c:majorGridlines>
        <c:minorGridlines>
          <c:spPr>
            <a:ln>
              <a:solidFill>
                <a:sysClr val="windowText" lastClr="000000">
                  <a:alpha val="22000"/>
                </a:sysClr>
              </a:solidFill>
              <a:prstDash val="sysDash"/>
            </a:ln>
          </c:spPr>
        </c:minorGridlines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baseline="0"/>
                  <a:t>Normalized peak height ratio</a:t>
                </a:r>
                <a:endParaRPr lang="pl-PL" sz="1000" b="1" i="0" baseline="0"/>
              </a:p>
            </c:rich>
          </c:tx>
          <c:layout/>
          <c:overlay val="0"/>
        </c:title>
        <c:numFmt formatCode="General" sourceLinked="1"/>
        <c:majorTickMark val="none"/>
        <c:minorTickMark val="in"/>
        <c:tickLblPos val="nextTo"/>
        <c:spPr>
          <a:noFill/>
        </c:spPr>
        <c:txPr>
          <a:bodyPr rot="0" vert="horz"/>
          <a:lstStyle/>
          <a:p>
            <a:pPr>
              <a:defRPr/>
            </a:pPr>
            <a:endParaRPr lang="pl-PL"/>
          </a:p>
        </c:txPr>
        <c:crossAx val="146746752"/>
        <c:crosses val="autoZero"/>
        <c:crossBetween val="between"/>
        <c:majorUnit val="0.5"/>
        <c:minorUnit val="0.05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546040666078565"/>
          <c:y val="4.2908288637833379E-2"/>
          <c:w val="0.87056541168868506"/>
          <c:h val="0.784392863935486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6600"/>
            </a:solidFill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70C0"/>
              </a:solidFill>
            </c:spPr>
          </c:dPt>
          <c:cat>
            <c:strRef>
              <c:f>Arkusz1!$C$89:$N$89</c:f>
              <c:strCache>
                <c:ptCount val="12"/>
                <c:pt idx="0">
                  <c:v>1. Wt</c:v>
                </c:pt>
                <c:pt idx="1">
                  <c:v>2. Deletion</c:v>
                </c:pt>
                <c:pt idx="2">
                  <c:v>3. Deletion</c:v>
                </c:pt>
                <c:pt idx="3">
                  <c:v>4. Wt</c:v>
                </c:pt>
                <c:pt idx="4">
                  <c:v>5. Wt</c:v>
                </c:pt>
                <c:pt idx="5">
                  <c:v>6. Wt</c:v>
                </c:pt>
                <c:pt idx="6">
                  <c:v>7. Wt</c:v>
                </c:pt>
                <c:pt idx="7">
                  <c:v>8. Wt</c:v>
                </c:pt>
                <c:pt idx="8">
                  <c:v>9. Wt</c:v>
                </c:pt>
                <c:pt idx="9">
                  <c:v>10. Wt</c:v>
                </c:pt>
                <c:pt idx="10">
                  <c:v>11. Wt</c:v>
                </c:pt>
                <c:pt idx="11">
                  <c:v>12. Wt</c:v>
                </c:pt>
              </c:strCache>
            </c:strRef>
          </c:cat>
          <c:val>
            <c:numRef>
              <c:f>[2]Arkusz1!$C$10:$N$10</c:f>
              <c:numCache>
                <c:formatCode>General</c:formatCode>
                <c:ptCount val="12"/>
                <c:pt idx="0">
                  <c:v>1.0264538365337406</c:v>
                </c:pt>
                <c:pt idx="1">
                  <c:v>0.48844114953689777</c:v>
                </c:pt>
                <c:pt idx="2">
                  <c:v>0.54883866979921958</c:v>
                </c:pt>
                <c:pt idx="3">
                  <c:v>1.0243817246414588</c:v>
                </c:pt>
                <c:pt idx="4">
                  <c:v>0.96075956558536302</c:v>
                </c:pt>
                <c:pt idx="5">
                  <c:v>0.99621656047681795</c:v>
                </c:pt>
                <c:pt idx="6">
                  <c:v>0.91300000000000003</c:v>
                </c:pt>
                <c:pt idx="7">
                  <c:v>1.0800337417789698</c:v>
                </c:pt>
                <c:pt idx="8">
                  <c:v>1.0299784994152898</c:v>
                </c:pt>
                <c:pt idx="9">
                  <c:v>0.9409667867129633</c:v>
                </c:pt>
                <c:pt idx="10">
                  <c:v>0.98873768822703589</c:v>
                </c:pt>
                <c:pt idx="11">
                  <c:v>1.04031702564471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731392"/>
        <c:axId val="146732928"/>
      </c:barChart>
      <c:catAx>
        <c:axId val="146731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pl-PL"/>
          </a:p>
        </c:txPr>
        <c:crossAx val="14673292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46732928"/>
        <c:scaling>
          <c:orientation val="minMax"/>
        </c:scaling>
        <c:delete val="0"/>
        <c:axPos val="l"/>
        <c:majorGridlines>
          <c:spPr>
            <a:ln>
              <a:solidFill>
                <a:srgbClr val="000000"/>
              </a:solidFill>
            </a:ln>
          </c:spPr>
        </c:majorGridlines>
        <c:minorGridlines>
          <c:spPr>
            <a:ln>
              <a:solidFill>
                <a:sysClr val="windowText" lastClr="000000">
                  <a:alpha val="22000"/>
                </a:sysClr>
              </a:solidFill>
              <a:prstDash val="sysDash"/>
            </a:ln>
          </c:spPr>
        </c:minorGridlines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baseline="0"/>
                  <a:t>Normalized peak height ratio</a:t>
                </a:r>
                <a:endParaRPr lang="pl-PL" sz="1000" b="1" i="0" baseline="0"/>
              </a:p>
            </c:rich>
          </c:tx>
          <c:layout>
            <c:manualLayout>
              <c:xMode val="edge"/>
              <c:yMode val="edge"/>
              <c:x val="3.6548647092688541E-2"/>
              <c:y val="0.18842019354086531"/>
            </c:manualLayout>
          </c:layout>
          <c:overlay val="0"/>
        </c:title>
        <c:numFmt formatCode="General" sourceLinked="1"/>
        <c:majorTickMark val="none"/>
        <c:minorTickMark val="in"/>
        <c:tickLblPos val="nextTo"/>
        <c:spPr>
          <a:noFill/>
        </c:spPr>
        <c:txPr>
          <a:bodyPr rot="0" vert="horz"/>
          <a:lstStyle/>
          <a:p>
            <a:pPr>
              <a:defRPr/>
            </a:pPr>
            <a:endParaRPr lang="pl-PL"/>
          </a:p>
        </c:txPr>
        <c:crossAx val="146731392"/>
        <c:crosses val="autoZero"/>
        <c:crossBetween val="between"/>
        <c:majorUnit val="0.5"/>
        <c:minorUnit val="0.05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26"/>
    </mc:Choice>
    <mc:Fallback>
      <c:style val="26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46040666078565"/>
          <c:y val="4.2908288637833365E-2"/>
          <c:w val="0.87056541168868495"/>
          <c:h val="0.784392863935486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rkusz1!$B$142</c:f>
              <c:strCache>
                <c:ptCount val="1"/>
                <c:pt idx="0">
                  <c:v>Normalized peak height ratio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1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2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3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4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5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6"/>
            <c:invertIfNegative val="0"/>
            <c:bubble3D val="0"/>
            <c:spPr>
              <a:solidFill>
                <a:srgbClr val="0070C0"/>
              </a:solidFill>
            </c:spPr>
          </c:dPt>
          <c:dPt>
            <c:idx val="7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8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9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10"/>
            <c:invertIfNegative val="0"/>
            <c:bubble3D val="0"/>
            <c:spPr>
              <a:solidFill>
                <a:srgbClr val="006600"/>
              </a:solidFill>
            </c:spPr>
          </c:dPt>
          <c:dPt>
            <c:idx val="11"/>
            <c:invertIfNegative val="0"/>
            <c:bubble3D val="0"/>
            <c:spPr>
              <a:solidFill>
                <a:srgbClr val="006600"/>
              </a:solidFill>
            </c:spPr>
          </c:dPt>
          <c:cat>
            <c:strRef>
              <c:f>Arkusz1!$C$144:$N$144</c:f>
              <c:strCache>
                <c:ptCount val="12"/>
                <c:pt idx="0">
                  <c:v>1. Wt</c:v>
                </c:pt>
                <c:pt idx="1">
                  <c:v>2. Wt</c:v>
                </c:pt>
                <c:pt idx="2">
                  <c:v>3. Wt</c:v>
                </c:pt>
                <c:pt idx="3">
                  <c:v>4. Wt</c:v>
                </c:pt>
                <c:pt idx="4">
                  <c:v>5. Deletion</c:v>
                </c:pt>
                <c:pt idx="5">
                  <c:v>6. Deletion</c:v>
                </c:pt>
                <c:pt idx="6">
                  <c:v>7. Deletion</c:v>
                </c:pt>
                <c:pt idx="7">
                  <c:v>8. Wt</c:v>
                </c:pt>
                <c:pt idx="8">
                  <c:v>9. Wt</c:v>
                </c:pt>
                <c:pt idx="9">
                  <c:v>10. Wt</c:v>
                </c:pt>
                <c:pt idx="10">
                  <c:v>11. Wt</c:v>
                </c:pt>
                <c:pt idx="11">
                  <c:v>12. Wt</c:v>
                </c:pt>
              </c:strCache>
            </c:strRef>
          </c:cat>
          <c:val>
            <c:numRef>
              <c:f>Arkusz1!$C$142:$N$142</c:f>
              <c:numCache>
                <c:formatCode>General</c:formatCode>
                <c:ptCount val="12"/>
                <c:pt idx="0">
                  <c:v>1.0581978860321422</c:v>
                </c:pt>
                <c:pt idx="1">
                  <c:v>1.0300163086022982</c:v>
                </c:pt>
                <c:pt idx="2">
                  <c:v>0.97200730677045966</c:v>
                </c:pt>
                <c:pt idx="3">
                  <c:v>0.96465993902584701</c:v>
                </c:pt>
                <c:pt idx="4">
                  <c:v>0.46182745604740338</c:v>
                </c:pt>
                <c:pt idx="5">
                  <c:v>0.43785405422356682</c:v>
                </c:pt>
                <c:pt idx="6">
                  <c:v>0.43875018728581816</c:v>
                </c:pt>
                <c:pt idx="7">
                  <c:v>1.0839893243597141</c:v>
                </c:pt>
                <c:pt idx="8">
                  <c:v>0.99231608706223906</c:v>
                </c:pt>
                <c:pt idx="9">
                  <c:v>0.9636716583933812</c:v>
                </c:pt>
                <c:pt idx="10">
                  <c:v>1.0202684972184093</c:v>
                </c:pt>
                <c:pt idx="11">
                  <c:v>0.974055280185440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923904"/>
        <c:axId val="146925440"/>
      </c:barChart>
      <c:catAx>
        <c:axId val="146923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0" vert="horz"/>
          <a:lstStyle/>
          <a:p>
            <a:pPr>
              <a:defRPr/>
            </a:pPr>
            <a:endParaRPr lang="pl-PL"/>
          </a:p>
        </c:txPr>
        <c:crossAx val="1469254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146925440"/>
        <c:scaling>
          <c:orientation val="minMax"/>
        </c:scaling>
        <c:delete val="0"/>
        <c:axPos val="l"/>
        <c:majorGridlines>
          <c:spPr>
            <a:ln>
              <a:solidFill>
                <a:srgbClr val="000000"/>
              </a:solidFill>
            </a:ln>
          </c:spPr>
        </c:majorGridlines>
        <c:minorGridlines>
          <c:spPr>
            <a:ln>
              <a:solidFill>
                <a:sysClr val="windowText" lastClr="000000">
                  <a:alpha val="22000"/>
                </a:sysClr>
              </a:solidFill>
              <a:prstDash val="sysDash"/>
            </a:ln>
          </c:spPr>
        </c:minorGridlines>
        <c:title>
          <c:tx>
            <c:rich>
              <a:bodyPr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baseline="0"/>
                  <a:t>Normalized peak height ratio</a:t>
                </a:r>
                <a:endParaRPr lang="pl-PL" sz="1000"/>
              </a:p>
            </c:rich>
          </c:tx>
          <c:layout/>
          <c:overlay val="0"/>
        </c:title>
        <c:numFmt formatCode="General" sourceLinked="1"/>
        <c:majorTickMark val="none"/>
        <c:minorTickMark val="in"/>
        <c:tickLblPos val="nextTo"/>
        <c:spPr>
          <a:noFill/>
        </c:spPr>
        <c:txPr>
          <a:bodyPr rot="0" vert="horz"/>
          <a:lstStyle/>
          <a:p>
            <a:pPr>
              <a:defRPr/>
            </a:pPr>
            <a:endParaRPr lang="pl-PL"/>
          </a:p>
        </c:txPr>
        <c:crossAx val="146923904"/>
        <c:crosses val="autoZero"/>
        <c:crossBetween val="between"/>
        <c:majorUnit val="0.5"/>
        <c:minorUnit val="0.0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17FA3B-C404-4317-B0BC-953931111309}" type="datetimeFigureOut">
              <a:rPr lang="pl-PL" smtClean="0"/>
              <a:t>2013-09-23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1897F-8F23-433E-A660-EFF8D3EDA506}" type="slidenum">
              <a:rPr lang="pl-PL" smtClean="0"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4590932"/>
              </p:ext>
            </p:extLst>
          </p:nvPr>
        </p:nvGraphicFramePr>
        <p:xfrm>
          <a:off x="928662" y="714356"/>
          <a:ext cx="7715304" cy="1214445"/>
        </p:xfrm>
        <a:graphic>
          <a:graphicData uri="http://schemas.openxmlformats.org/drawingml/2006/table">
            <a:tbl>
              <a:tblPr/>
              <a:tblGrid>
                <a:gridCol w="2541552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74144"/>
                <a:gridCol w="446252"/>
                <a:gridCol w="488089"/>
              </a:tblGrid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 dirty="0" err="1">
                          <a:solidFill>
                            <a:srgbClr val="FFFFFF"/>
                          </a:solidFill>
                          <a:latin typeface="Arial"/>
                        </a:rPr>
                        <a:t>Sample</a:t>
                      </a:r>
                      <a:r>
                        <a:rPr lang="pl-PL" sz="900" b="1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 No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398253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9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2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9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0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1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4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4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4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5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,49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,3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,7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arget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7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4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8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1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0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6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7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7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8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5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4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2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8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2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7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2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2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8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8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4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4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3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5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9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5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9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5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9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0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9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5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4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</a:tr>
            </a:tbl>
          </a:graphicData>
        </a:graphic>
      </p:graphicFrame>
      <p:sp>
        <p:nvSpPr>
          <p:cNvPr id="7" name="pole tekstowe 4570"/>
          <p:cNvSpPr txBox="1">
            <a:spLocks noChangeArrowheads="1"/>
          </p:cNvSpPr>
          <p:nvPr/>
        </p:nvSpPr>
        <p:spPr bwMode="auto">
          <a:xfrm>
            <a:off x="0" y="642918"/>
            <a:ext cx="4363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a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8" name="pole tekstowe 4570"/>
          <p:cNvSpPr txBox="1">
            <a:spLocks noChangeArrowheads="1"/>
          </p:cNvSpPr>
          <p:nvPr/>
        </p:nvSpPr>
        <p:spPr bwMode="auto">
          <a:xfrm>
            <a:off x="0" y="2000240"/>
            <a:ext cx="44755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b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18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6327786"/>
              </p:ext>
            </p:extLst>
          </p:nvPr>
        </p:nvGraphicFramePr>
        <p:xfrm>
          <a:off x="-457201" y="2369572"/>
          <a:ext cx="9601201" cy="3695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Prostokąt 1"/>
          <p:cNvSpPr/>
          <p:nvPr/>
        </p:nvSpPr>
        <p:spPr>
          <a:xfrm>
            <a:off x="611560" y="5930087"/>
            <a:ext cx="794756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The </a:t>
            </a:r>
            <a:r>
              <a:rPr lang="en-US" sz="1200" dirty="0"/>
              <a:t>examination of the DMD gene exon 9. The example of detection of CNVs encompassing exon 9. (a) Peak height ratio calculations based on the results from melting after the 30</a:t>
            </a:r>
            <a:r>
              <a:rPr lang="en-US" sz="1200" baseline="30000" dirty="0"/>
              <a:t>th</a:t>
            </a:r>
            <a:r>
              <a:rPr lang="en-US" sz="1200" dirty="0"/>
              <a:t> cycle (b) Graph results. Yellow columns represent samples with duplication, blue columns represent </a:t>
            </a:r>
            <a:r>
              <a:rPr lang="en-US" sz="1200" dirty="0" err="1"/>
              <a:t>hemizygotes</a:t>
            </a:r>
            <a:r>
              <a:rPr lang="en-US" sz="1200" dirty="0"/>
              <a:t>, red column represents a male </a:t>
            </a:r>
            <a:r>
              <a:rPr lang="en-US" sz="1200" dirty="0" err="1"/>
              <a:t>hemizygote</a:t>
            </a:r>
            <a:r>
              <a:rPr lang="en-US" sz="1200" dirty="0"/>
              <a:t> with duplication, green columns represent wild types. </a:t>
            </a:r>
            <a:endParaRPr lang="pl-PL" sz="1200" dirty="0"/>
          </a:p>
        </p:txBody>
      </p:sp>
      <p:sp>
        <p:nvSpPr>
          <p:cNvPr id="11" name="pole tekstowe 4563"/>
          <p:cNvSpPr txBox="1">
            <a:spLocks noChangeArrowheads="1"/>
          </p:cNvSpPr>
          <p:nvPr/>
        </p:nvSpPr>
        <p:spPr bwMode="auto">
          <a:xfrm>
            <a:off x="142844" y="142852"/>
            <a:ext cx="22199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pl-PL" dirty="0" err="1" smtClean="0">
                <a:latin typeface="Calibri" pitchFamily="34" charset="0"/>
              </a:rPr>
              <a:t>Supplementary</a:t>
            </a:r>
            <a:r>
              <a:rPr lang="pl-PL" dirty="0" smtClean="0">
                <a:latin typeface="Calibri" pitchFamily="34" charset="0"/>
              </a:rPr>
              <a:t> F</a:t>
            </a: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ig. </a:t>
            </a: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1.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7969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0889782"/>
              </p:ext>
            </p:extLst>
          </p:nvPr>
        </p:nvGraphicFramePr>
        <p:xfrm>
          <a:off x="857224" y="1857364"/>
          <a:ext cx="7642800" cy="343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pole tekstowe 4570"/>
          <p:cNvSpPr txBox="1">
            <a:spLocks noChangeArrowheads="1"/>
          </p:cNvSpPr>
          <p:nvPr/>
        </p:nvSpPr>
        <p:spPr bwMode="auto">
          <a:xfrm>
            <a:off x="428596" y="571480"/>
            <a:ext cx="4363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a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pole tekstowe 4570"/>
          <p:cNvSpPr txBox="1">
            <a:spLocks noChangeArrowheads="1"/>
          </p:cNvSpPr>
          <p:nvPr/>
        </p:nvSpPr>
        <p:spPr bwMode="auto">
          <a:xfrm>
            <a:off x="428596" y="1928802"/>
            <a:ext cx="44755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b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5" name="pole tekstowe 4563"/>
          <p:cNvSpPr txBox="1">
            <a:spLocks noChangeArrowheads="1"/>
          </p:cNvSpPr>
          <p:nvPr/>
        </p:nvSpPr>
        <p:spPr bwMode="auto">
          <a:xfrm>
            <a:off x="142844" y="142852"/>
            <a:ext cx="22199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pl-PL" dirty="0" err="1" smtClean="0">
                <a:latin typeface="Calibri" pitchFamily="34" charset="0"/>
              </a:rPr>
              <a:t>Supplementary</a:t>
            </a:r>
            <a:r>
              <a:rPr lang="pl-PL" dirty="0" smtClean="0">
                <a:latin typeface="Calibri" pitchFamily="34" charset="0"/>
              </a:rPr>
              <a:t> F</a:t>
            </a: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ig. 2.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14" name="Tabela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1363637"/>
              </p:ext>
            </p:extLst>
          </p:nvPr>
        </p:nvGraphicFramePr>
        <p:xfrm>
          <a:off x="857224" y="642918"/>
          <a:ext cx="7715304" cy="1214445"/>
        </p:xfrm>
        <a:graphic>
          <a:graphicData uri="http://schemas.openxmlformats.org/drawingml/2006/table">
            <a:tbl>
              <a:tblPr/>
              <a:tblGrid>
                <a:gridCol w="2541552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74144"/>
                <a:gridCol w="446252"/>
                <a:gridCol w="488089"/>
              </a:tblGrid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 dirty="0" err="1">
                          <a:solidFill>
                            <a:srgbClr val="FFFFFF"/>
                          </a:solidFill>
                          <a:latin typeface="Arial"/>
                        </a:rPr>
                        <a:t>Sample</a:t>
                      </a:r>
                      <a:r>
                        <a:rPr lang="pl-PL" sz="900" b="1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 No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398253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1,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1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,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8,5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2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1,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0,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49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6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0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7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arget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4,249</a:t>
                      </a:r>
                      <a:endParaRPr lang="pl-PL" sz="9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5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62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1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1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6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2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9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1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0,688</a:t>
                      </a:r>
                      <a:endParaRPr lang="pl-PL" sz="9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3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4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7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7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76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8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7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Normalized</a:t>
                      </a:r>
                      <a:r>
                        <a:rPr lang="pl-PL" sz="9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pl-PL" sz="900" b="1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peak</a:t>
                      </a:r>
                      <a:r>
                        <a:rPr lang="pl-PL" sz="9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pl-PL" sz="900" b="1" i="0" u="none" strike="noStrike" dirty="0" err="1">
                          <a:solidFill>
                            <a:srgbClr val="000000"/>
                          </a:solidFill>
                          <a:latin typeface="Arial"/>
                        </a:rPr>
                        <a:t>height</a:t>
                      </a:r>
                      <a:r>
                        <a:rPr lang="pl-PL" sz="900" b="1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 smtClean="0">
                          <a:solidFill>
                            <a:srgbClr val="000000"/>
                          </a:solidFill>
                          <a:latin typeface="Arial"/>
                        </a:rPr>
                        <a:t>0,913</a:t>
                      </a:r>
                      <a:endParaRPr lang="pl-PL" sz="900" b="0" i="0" u="none" strike="noStrike" dirty="0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,5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5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0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,9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70C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</a:tbl>
          </a:graphicData>
        </a:graphic>
      </p:graphicFrame>
      <p:sp>
        <p:nvSpPr>
          <p:cNvPr id="6" name="Prostokąt 5"/>
          <p:cNvSpPr/>
          <p:nvPr/>
        </p:nvSpPr>
        <p:spPr>
          <a:xfrm>
            <a:off x="1619672" y="5301208"/>
            <a:ext cx="684076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1200" dirty="0" smtClean="0"/>
              <a:t>T</a:t>
            </a:r>
            <a:r>
              <a:rPr lang="en-US" sz="1200" dirty="0" smtClean="0"/>
              <a:t>he </a:t>
            </a:r>
            <a:r>
              <a:rPr lang="en-US" sz="1200" dirty="0"/>
              <a:t>examination of the DMD gene exon 49. The example of detection of CNVs encompassing exon 49. (a) Peak height ratio calculations based on the results from melting after the 30</a:t>
            </a:r>
            <a:r>
              <a:rPr lang="en-US" sz="1200" baseline="30000" dirty="0"/>
              <a:t>th</a:t>
            </a:r>
            <a:r>
              <a:rPr lang="en-US" sz="1200" dirty="0"/>
              <a:t> cycle (b) Graph results. Blue columns represent samples with deletion of 1 allele, red columns represent </a:t>
            </a:r>
            <a:r>
              <a:rPr lang="en-US" sz="1200" dirty="0" err="1"/>
              <a:t>hemizygotes</a:t>
            </a:r>
            <a:r>
              <a:rPr lang="en-US" sz="1200" dirty="0"/>
              <a:t> with deletion (resulting in a lack of amplification of the target </a:t>
            </a:r>
            <a:r>
              <a:rPr lang="en-US" sz="1200" dirty="0" err="1"/>
              <a:t>amplicon</a:t>
            </a:r>
            <a:r>
              <a:rPr lang="en-US" sz="1200" dirty="0"/>
              <a:t>), green columns represent wild types. 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4248071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ole tekstowe 4570"/>
          <p:cNvSpPr txBox="1">
            <a:spLocks noChangeArrowheads="1"/>
          </p:cNvSpPr>
          <p:nvPr/>
        </p:nvSpPr>
        <p:spPr bwMode="auto">
          <a:xfrm>
            <a:off x="428596" y="571480"/>
            <a:ext cx="4363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a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pole tekstowe 4570"/>
          <p:cNvSpPr txBox="1">
            <a:spLocks noChangeArrowheads="1"/>
          </p:cNvSpPr>
          <p:nvPr/>
        </p:nvSpPr>
        <p:spPr bwMode="auto">
          <a:xfrm>
            <a:off x="428596" y="1928802"/>
            <a:ext cx="44755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b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5" name="pole tekstowe 4563"/>
          <p:cNvSpPr txBox="1">
            <a:spLocks noChangeArrowheads="1"/>
          </p:cNvSpPr>
          <p:nvPr/>
        </p:nvSpPr>
        <p:spPr bwMode="auto">
          <a:xfrm>
            <a:off x="142844" y="142852"/>
            <a:ext cx="22199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pl-PL" dirty="0" err="1">
                <a:latin typeface="Calibri" pitchFamily="34" charset="0"/>
              </a:rPr>
              <a:t>Supplementary</a:t>
            </a:r>
            <a:r>
              <a:rPr lang="pl-PL" dirty="0">
                <a:latin typeface="Calibri" pitchFamily="34" charset="0"/>
              </a:rPr>
              <a:t> Fig. 3</a:t>
            </a:r>
            <a:r>
              <a:rPr lang="pl-PL" dirty="0" smtClean="0">
                <a:latin typeface="Calibri" pitchFamily="34" charset="0"/>
              </a:rPr>
              <a:t>.</a:t>
            </a:r>
            <a:endParaRPr lang="pl-PL" dirty="0">
              <a:latin typeface="Arial" pitchFamily="34" charset="0"/>
            </a:endParaRPr>
          </a:p>
        </p:txBody>
      </p:sp>
      <p:graphicFrame>
        <p:nvGraphicFramePr>
          <p:cNvPr id="6" name="Tabela 5"/>
          <p:cNvGraphicFramePr>
            <a:graphicFrameLocks noGrp="1"/>
          </p:cNvGraphicFramePr>
          <p:nvPr/>
        </p:nvGraphicFramePr>
        <p:xfrm>
          <a:off x="857224" y="642918"/>
          <a:ext cx="7715304" cy="1214445"/>
        </p:xfrm>
        <a:graphic>
          <a:graphicData uri="http://schemas.openxmlformats.org/drawingml/2006/table">
            <a:tbl>
              <a:tblPr/>
              <a:tblGrid>
                <a:gridCol w="2541552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74144"/>
                <a:gridCol w="446252"/>
                <a:gridCol w="488089"/>
              </a:tblGrid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 dirty="0" err="1">
                          <a:solidFill>
                            <a:srgbClr val="FFFFFF"/>
                          </a:solidFill>
                          <a:latin typeface="Arial"/>
                        </a:rPr>
                        <a:t>Sample</a:t>
                      </a:r>
                      <a:r>
                        <a:rPr lang="pl-PL" sz="900" b="1" i="0" u="none" strike="noStrike" dirty="0">
                          <a:solidFill>
                            <a:srgbClr val="FFFFFF"/>
                          </a:solidFill>
                          <a:latin typeface="Arial"/>
                        </a:rPr>
                        <a:t> No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398253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0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6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8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2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7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8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3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34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5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7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4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5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arget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3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6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4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5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95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3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1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0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0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7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1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7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8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6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6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5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8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7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5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7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4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5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1,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" name="Chart 7"/>
          <p:cNvGraphicFramePr>
            <a:graphicFrameLocks/>
          </p:cNvGraphicFramePr>
          <p:nvPr/>
        </p:nvGraphicFramePr>
        <p:xfrm>
          <a:off x="857224" y="1857364"/>
          <a:ext cx="7642800" cy="343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Prostokąt 6"/>
          <p:cNvSpPr/>
          <p:nvPr/>
        </p:nvSpPr>
        <p:spPr>
          <a:xfrm>
            <a:off x="1532786" y="5229200"/>
            <a:ext cx="678363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The </a:t>
            </a:r>
            <a:r>
              <a:rPr lang="en-US" sz="1200" dirty="0"/>
              <a:t>examination of the APC gene exon 9. The example of detection of CNVs encompassing exon 9. (a) Peak height ratio calculations based on the results from melting after the 30</a:t>
            </a:r>
            <a:r>
              <a:rPr lang="en-US" sz="1200" baseline="30000" dirty="0"/>
              <a:t>th</a:t>
            </a:r>
            <a:r>
              <a:rPr lang="en-US" sz="1200" dirty="0"/>
              <a:t> cycle (b) Graph results. Blue columns represent samples with deletion of 1 allele, green columns represent wild types.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3181295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9"/>
          <p:cNvGraphicFramePr>
            <a:graphicFrameLocks/>
          </p:cNvGraphicFramePr>
          <p:nvPr/>
        </p:nvGraphicFramePr>
        <p:xfrm>
          <a:off x="857224" y="1857364"/>
          <a:ext cx="7643866" cy="34290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pole tekstowe 4570"/>
          <p:cNvSpPr txBox="1">
            <a:spLocks noChangeArrowheads="1"/>
          </p:cNvSpPr>
          <p:nvPr/>
        </p:nvSpPr>
        <p:spPr bwMode="auto">
          <a:xfrm>
            <a:off x="428596" y="571480"/>
            <a:ext cx="43633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a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" name="pole tekstowe 4570"/>
          <p:cNvSpPr txBox="1">
            <a:spLocks noChangeArrowheads="1"/>
          </p:cNvSpPr>
          <p:nvPr/>
        </p:nvSpPr>
        <p:spPr bwMode="auto">
          <a:xfrm>
            <a:off x="428596" y="1928802"/>
            <a:ext cx="44755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l-PL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(b)</a:t>
            </a:r>
            <a:endParaRPr kumimoji="0" lang="pl-PL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12" name="Tabela 11"/>
          <p:cNvGraphicFramePr>
            <a:graphicFrameLocks noGrp="1"/>
          </p:cNvGraphicFramePr>
          <p:nvPr/>
        </p:nvGraphicFramePr>
        <p:xfrm>
          <a:off x="857224" y="642918"/>
          <a:ext cx="7715304" cy="1214445"/>
        </p:xfrm>
        <a:graphic>
          <a:graphicData uri="http://schemas.openxmlformats.org/drawingml/2006/table">
            <a:tbl>
              <a:tblPr/>
              <a:tblGrid>
                <a:gridCol w="2541552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18363"/>
                <a:gridCol w="474144"/>
                <a:gridCol w="446252"/>
                <a:gridCol w="488089"/>
              </a:tblGrid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Sample No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FFFFFF"/>
                          </a:solidFill>
                          <a:latin typeface="Arial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F81BD"/>
                    </a:solidFill>
                  </a:tcPr>
                </a:tc>
              </a:tr>
              <a:tr h="398253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Reference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2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3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4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3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1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8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6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6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Target amplicon height maximu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7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4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2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0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3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4,1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3,7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3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6,1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5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4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5,3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5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5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4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4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68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6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6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6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46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4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5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4048"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1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Normalized peak height rati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4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4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4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366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9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0,96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>
                          <a:solidFill>
                            <a:srgbClr val="000000"/>
                          </a:solidFill>
                          <a:latin typeface="Arial"/>
                        </a:rPr>
                        <a:t>1,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900" b="0" i="0" u="none" strike="noStrike" dirty="0">
                          <a:solidFill>
                            <a:srgbClr val="000000"/>
                          </a:solidFill>
                          <a:latin typeface="Arial"/>
                        </a:rPr>
                        <a:t>0,9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4F81BD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000"/>
                    </a:solidFill>
                  </a:tcPr>
                </a:tc>
              </a:tr>
            </a:tbl>
          </a:graphicData>
        </a:graphic>
      </p:graphicFrame>
      <p:sp>
        <p:nvSpPr>
          <p:cNvPr id="8" name="pole tekstowe 4563"/>
          <p:cNvSpPr txBox="1">
            <a:spLocks noChangeArrowheads="1"/>
          </p:cNvSpPr>
          <p:nvPr/>
        </p:nvSpPr>
        <p:spPr bwMode="auto">
          <a:xfrm>
            <a:off x="142844" y="142852"/>
            <a:ext cx="22199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pl-PL" dirty="0" err="1">
                <a:latin typeface="Calibri" pitchFamily="34" charset="0"/>
              </a:rPr>
              <a:t>Supplementary</a:t>
            </a:r>
            <a:r>
              <a:rPr lang="pl-PL" dirty="0">
                <a:latin typeface="Calibri" pitchFamily="34" charset="0"/>
              </a:rPr>
              <a:t> Fig. </a:t>
            </a:r>
            <a:r>
              <a:rPr lang="pl-PL" dirty="0" smtClean="0">
                <a:latin typeface="Calibri" pitchFamily="34" charset="0"/>
              </a:rPr>
              <a:t>4.</a:t>
            </a:r>
            <a:endParaRPr lang="pl-PL" dirty="0">
              <a:latin typeface="Arial" pitchFamily="34" charset="0"/>
            </a:endParaRPr>
          </a:p>
        </p:txBody>
      </p:sp>
      <p:sp>
        <p:nvSpPr>
          <p:cNvPr id="4" name="Prostokąt 3"/>
          <p:cNvSpPr/>
          <p:nvPr/>
        </p:nvSpPr>
        <p:spPr>
          <a:xfrm>
            <a:off x="1331640" y="5229200"/>
            <a:ext cx="71287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The </a:t>
            </a:r>
            <a:r>
              <a:rPr lang="en-US" sz="1200" dirty="0"/>
              <a:t>examination of the APC gene exon 14. The example of detection of CNVs encompassing exon 14. (a) Peak height ratio calculations based on the results from melting after the 30</a:t>
            </a:r>
            <a:r>
              <a:rPr lang="en-US" sz="1200" baseline="30000" dirty="0"/>
              <a:t>th</a:t>
            </a:r>
            <a:r>
              <a:rPr lang="en-US" sz="1200" dirty="0"/>
              <a:t> cycle (b) Graph results. Blue columns represent samples with deletion of 1 allele, green columns represent wild types. 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1128187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Pakiet 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Pakiet 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Pakiet 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634</Words>
  <Application>Microsoft Office PowerPoint</Application>
  <PresentationFormat>Pokaz na ekranie (4:3)</PresentationFormat>
  <Paragraphs>280</Paragraphs>
  <Slides>4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4</vt:i4>
      </vt:variant>
    </vt:vector>
  </HeadingPairs>
  <TitlesOfParts>
    <vt:vector size="5" baseType="lpstr"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cp:lastModifiedBy>Paweł</cp:lastModifiedBy>
  <cp:revision>4</cp:revision>
  <dcterms:modified xsi:type="dcterms:W3CDTF">2013-09-23T11:35:30Z</dcterms:modified>
</cp:coreProperties>
</file>